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9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75" y="2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91A8F2-8C66-7FA8-4436-14A38825A8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6D9200F-94F8-8792-9FE6-923F6C621F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B9D838-55E4-2A9E-11E7-A075644F0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D06FA6-2D35-ACB9-59A6-080EA0C61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949310-E36A-B9BD-0F7A-587918391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331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7A71EF-466C-33BD-5F46-5034A9309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B99A31C-2A59-39B0-34EA-AED62EECEE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420A5E-D8BC-C877-9653-3DFC63BF8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797241-9E34-09C7-6AE2-211DCA91A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403351-97CA-F0B9-F0D2-D281EC458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900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766E48F-41BE-E75C-C6C3-C2DF1C216F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C3D7C42-B374-70BD-77CD-EC15C54C51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C12797-B96C-0D1B-D8C4-206E58195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9DA1D1-222D-E758-C67C-1CB4EAD5A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0E5A20-B786-0710-AFD5-3E4B24EF4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2803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347021-B63D-19AD-D0D4-B94C0EB296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0EBAB1B-D609-CEDB-F129-568437AD30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A8395C-FCFD-BD37-858A-90CE58F38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14D438-D966-224E-19A3-920C21521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AA6502-234E-2042-8F20-298EDFE7B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1329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35212D-C7F8-09BE-C078-C5008E594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7C39702-570C-1C74-E122-674443600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F2F3F5-4ACC-D9C0-0591-D07ADCEED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CAB683-D474-8554-DEDE-043957F02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128B41-210C-B08F-FE06-FFA75C02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4239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03608A-474A-FEBC-AA31-94A205724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8B38C2A-89A4-39F0-1662-9EEBACDC9E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1B2A04-4334-7ECC-6125-707F6C7717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D9C181-DC99-4019-2EB9-F74F96E3A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4655B2-2E45-45B9-9860-D6D492371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802025-14DB-2E2B-362F-64B3A3096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8530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B1F22D-B21F-493D-22DB-19C35EE7C9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FAA5B1-8DBF-6024-A0B3-CA0476F9F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9B3F279-CBAC-266E-1DFD-5655063B8E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9377073-F2C2-F8EF-A99A-6493AC760F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C962B1B-596D-D358-6D7C-9B4480BDB4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8A2AAF1-42BA-52EF-84AD-DF13E4434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0DA0012-25E0-DAFA-38A3-BA139DFA3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B837BE8-89DF-D3F2-D1B6-E27D29A403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2530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F94503-249E-E6FA-1560-E509690C7B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DEDF64E-136A-D202-2708-533346F4A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E2F1086-AA8C-B886-0EC2-C9BF87FA3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6E77564-3FCE-DF63-65AE-E895067FF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7022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287E9A4-A275-286E-01B7-75DC3D9BB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B5FA0F5-B820-8676-69B2-FF5FDF53E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C6AF100-C4A4-13AB-6092-CDBFCC2D93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5748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B477F1-4335-5402-21E0-A2E691447F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0D1FE9-342F-3F5E-6985-D7814079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A63C8DE-4B7E-2B17-0EE3-8D687449DC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47B34A-447A-2C1E-58DC-942DC3B38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D3E268-2605-CEAA-8A4F-7ECC8DADD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D9BEDC-483C-D329-083C-2AFEE5730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3008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95E36D-C06F-9B4A-8BCB-DEF728841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0EC1D17-5D11-F3B2-D2EB-D99D0E56B7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1397AC-0895-E94E-DB6E-3AB99353ED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ECD959B-D098-A102-5F52-BFED285B7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0C1A1CB-4953-EA57-8D69-54BFE0DEE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B54A1ED-BA26-BCBA-A6AD-D705E4F2F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6271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ABF9878-D88C-EF45-3B67-B9B334F26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364C38-E682-D4E3-3286-48E9E923B8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B56473-87CA-C3A6-C131-4FB0C48C60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869E3-76B9-4D3F-A5F7-29C46B97F5A2}" type="datetimeFigureOut">
              <a:rPr lang="zh-CN" altLang="en-US" smtClean="0"/>
              <a:t>2022/12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73D5D7-A702-E9CB-FF8A-CDCE416DB6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0D6728-CD66-D54A-0D7F-E6A7D66E76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590A1-8DA9-4CA0-ACA4-6BD98E7D99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3425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8AD600E7-9F45-953A-57AC-685D81296964}"/>
              </a:ext>
            </a:extLst>
          </p:cNvPr>
          <p:cNvGrpSpPr/>
          <p:nvPr/>
        </p:nvGrpSpPr>
        <p:grpSpPr bwMode="auto">
          <a:xfrm>
            <a:off x="4186237" y="1649412"/>
            <a:ext cx="3819525" cy="3559175"/>
            <a:chOff x="0" y="0"/>
            <a:chExt cx="2406" cy="2242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540831DF-8F49-6328-0023-987955E1D9F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2406" cy="22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E01E86A-5D80-7755-C2C6-F7FE856B8B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" y="939"/>
              <a:ext cx="974" cy="292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442088B8-0FFC-00BD-265A-9F61C4FBE3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" y="939"/>
              <a:ext cx="974" cy="292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9951F82-8BD1-A86D-DA23-E67B579C97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4" y="1037"/>
              <a:ext cx="70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Edge computing node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BF3C4EBC-3735-A812-A800-97612077AE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" y="1939"/>
              <a:ext cx="974" cy="293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D1DD7E3-1B9E-BAF1-DE1D-E6916D7048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9" y="1939"/>
              <a:ext cx="974" cy="293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A730D05-91C6-9E8E-DECD-274EB4A6B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9" y="2039"/>
              <a:ext cx="53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utonomous car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D9B02070-7071-ED4B-CA24-D87A57785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" y="1445"/>
              <a:ext cx="682" cy="293"/>
            </a:xfrm>
            <a:prstGeom prst="rect">
              <a:avLst/>
            </a:prstGeom>
            <a:solidFill>
              <a:srgbClr val="9DBB6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D7A560E1-B4E9-4E39-67F1-935CEEBDCA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" y="1445"/>
              <a:ext cx="682" cy="293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0D92F222-225D-F0B8-51DD-94A60E877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" y="1545"/>
              <a:ext cx="37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ensor data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A503F08-3230-6ABD-23F4-BB1701FBDF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1445"/>
              <a:ext cx="680" cy="293"/>
            </a:xfrm>
            <a:prstGeom prst="rect">
              <a:avLst/>
            </a:prstGeom>
            <a:solidFill>
              <a:srgbClr val="9DBB6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B2ABC298-0924-4BBE-E10A-91CACF4AA5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1445"/>
              <a:ext cx="680" cy="293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5D46C2C1-7F28-FFB2-260E-118AB42D96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2" y="1545"/>
              <a:ext cx="64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he decision results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8F708F67-658B-B4C7-2E60-C1E318C6A2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" y="431"/>
              <a:ext cx="682" cy="292"/>
            </a:xfrm>
            <a:prstGeom prst="rect">
              <a:avLst/>
            </a:prstGeom>
            <a:solidFill>
              <a:srgbClr val="92CD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69BAD056-FC6D-F661-AFB2-C1CC0D6A0E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" y="431"/>
              <a:ext cx="682" cy="292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6017A96-91ED-07C8-A8E0-B675E61CB1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" y="481"/>
              <a:ext cx="13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on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E0B163E8-3107-E777-6B7E-54F0F4FFA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" y="481"/>
              <a:ext cx="2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-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C1030682-943D-87AC-3908-D7C817B11E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" y="481"/>
              <a:ext cx="47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delay sensitive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DCFA94D9-D550-33B7-483E-410BBCB6F6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" y="578"/>
              <a:ext cx="50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ervice requests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777037CF-9962-D090-6C00-3B83A6341A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431"/>
              <a:ext cx="680" cy="292"/>
            </a:xfrm>
            <a:prstGeom prst="rect">
              <a:avLst/>
            </a:prstGeom>
            <a:solidFill>
              <a:srgbClr val="92CD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50EF6F3-E71A-FF81-D44C-FAF038CDCC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2" y="431"/>
              <a:ext cx="680" cy="292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CB51E70-81D3-0656-1894-6A3EE9D63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6" y="481"/>
              <a:ext cx="63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High precision map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96985B66-14F3-0CF6-1F8D-7F671A37DB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" y="578"/>
              <a:ext cx="43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model update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3B32028-AE00-429C-16A9-F2546D1C07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" y="10"/>
              <a:ext cx="680" cy="292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B648A240-1DAB-B7EB-BC14-338DF7EC3C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" y="10"/>
              <a:ext cx="680" cy="292"/>
            </a:xfrm>
            <a:prstGeom prst="rect">
              <a:avLst/>
            </a:prstGeom>
            <a:noFill/>
            <a:ln w="1588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D8883C61-768A-2F9C-3B37-C86E1A5AC1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" y="61"/>
              <a:ext cx="57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loud Computing </a:t>
              </a:r>
              <a:endParaRPr lang="zh-CN" sz="1200" kern="10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3A16251D-AC1D-C8E5-66EF-EE7A921B97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8" y="157"/>
              <a:ext cx="21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just" eaLnBrk="0" fontAlgn="base" hangingPunct="0"/>
              <a:r>
                <a:rPr lang="zh-CN" sz="10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enter</a:t>
              </a:r>
              <a:endParaRPr 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endParaRPr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FBBDA6D5-8B2C-5BA9-0CAA-1AEE26282E3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" y="156"/>
              <a:ext cx="441" cy="275"/>
            </a:xfrm>
            <a:custGeom>
              <a:avLst/>
              <a:gdLst>
                <a:gd name="T0" fmla="*/ 0 w 441"/>
                <a:gd name="T1" fmla="*/ 275 h 275"/>
                <a:gd name="T2" fmla="*/ 0 w 441"/>
                <a:gd name="T3" fmla="*/ 0 h 275"/>
                <a:gd name="T4" fmla="*/ 441 w 441"/>
                <a:gd name="T5" fmla="*/ 0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1" h="275">
                  <a:moveTo>
                    <a:pt x="0" y="275"/>
                  </a:moveTo>
                  <a:lnTo>
                    <a:pt x="0" y="0"/>
                  </a:lnTo>
                  <a:lnTo>
                    <a:pt x="441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7435DDA3-B963-196D-3FD1-CEE0ED541C92}"/>
                </a:ext>
              </a:extLst>
            </p:cNvPr>
            <p:cNvSpPr>
              <a:spLocks/>
            </p:cNvSpPr>
            <p:nvPr/>
          </p:nvSpPr>
          <p:spPr bwMode="auto">
            <a:xfrm>
              <a:off x="802" y="129"/>
              <a:ext cx="53" cy="53"/>
            </a:xfrm>
            <a:custGeom>
              <a:avLst/>
              <a:gdLst>
                <a:gd name="T0" fmla="*/ 0 w 53"/>
                <a:gd name="T1" fmla="*/ 0 h 53"/>
                <a:gd name="T2" fmla="*/ 53 w 53"/>
                <a:gd name="T3" fmla="*/ 27 h 53"/>
                <a:gd name="T4" fmla="*/ 0 w 53"/>
                <a:gd name="T5" fmla="*/ 53 h 53"/>
                <a:gd name="T6" fmla="*/ 0 w 53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" h="53">
                  <a:moveTo>
                    <a:pt x="0" y="0"/>
                  </a:moveTo>
                  <a:lnTo>
                    <a:pt x="53" y="27"/>
                  </a:lnTo>
                  <a:lnTo>
                    <a:pt x="0" y="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id="{17FC8B80-17A5-9286-EC6A-CE5FF2B456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5" y="156"/>
              <a:ext cx="487" cy="228"/>
            </a:xfrm>
            <a:custGeom>
              <a:avLst/>
              <a:gdLst>
                <a:gd name="T0" fmla="*/ 0 w 487"/>
                <a:gd name="T1" fmla="*/ 0 h 228"/>
                <a:gd name="T2" fmla="*/ 487 w 487"/>
                <a:gd name="T3" fmla="*/ 0 h 228"/>
                <a:gd name="T4" fmla="*/ 487 w 487"/>
                <a:gd name="T5" fmla="*/ 228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7" h="228">
                  <a:moveTo>
                    <a:pt x="0" y="0"/>
                  </a:moveTo>
                  <a:lnTo>
                    <a:pt x="487" y="0"/>
                  </a:lnTo>
                  <a:lnTo>
                    <a:pt x="487" y="22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FF576A9D-5A8B-F296-AB80-BE4AA6B516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6" y="378"/>
              <a:ext cx="51" cy="53"/>
            </a:xfrm>
            <a:custGeom>
              <a:avLst/>
              <a:gdLst>
                <a:gd name="T0" fmla="*/ 51 w 51"/>
                <a:gd name="T1" fmla="*/ 0 h 53"/>
                <a:gd name="T2" fmla="*/ 26 w 51"/>
                <a:gd name="T3" fmla="*/ 53 h 53"/>
                <a:gd name="T4" fmla="*/ 0 w 51"/>
                <a:gd name="T5" fmla="*/ 0 h 53"/>
                <a:gd name="T6" fmla="*/ 51 w 51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3">
                  <a:moveTo>
                    <a:pt x="51" y="0"/>
                  </a:moveTo>
                  <a:lnTo>
                    <a:pt x="26" y="53"/>
                  </a:lnTo>
                  <a:lnTo>
                    <a:pt x="0" y="0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28266A59-F5C3-C56A-C3E4-699E875E213E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9" y="1738"/>
              <a:ext cx="293" cy="348"/>
            </a:xfrm>
            <a:custGeom>
              <a:avLst/>
              <a:gdLst>
                <a:gd name="T0" fmla="*/ 293 w 293"/>
                <a:gd name="T1" fmla="*/ 0 h 348"/>
                <a:gd name="T2" fmla="*/ 293 w 293"/>
                <a:gd name="T3" fmla="*/ 348 h 348"/>
                <a:gd name="T4" fmla="*/ 0 w 293"/>
                <a:gd name="T5" fmla="*/ 348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3" h="348">
                  <a:moveTo>
                    <a:pt x="293" y="0"/>
                  </a:moveTo>
                  <a:lnTo>
                    <a:pt x="293" y="348"/>
                  </a:lnTo>
                  <a:lnTo>
                    <a:pt x="0" y="34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A89347E0-8CFE-A5A9-CA47-9A2F7BFB6C5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3" y="2060"/>
              <a:ext cx="51" cy="51"/>
            </a:xfrm>
            <a:custGeom>
              <a:avLst/>
              <a:gdLst>
                <a:gd name="T0" fmla="*/ 51 w 51"/>
                <a:gd name="T1" fmla="*/ 51 h 51"/>
                <a:gd name="T2" fmla="*/ 0 w 51"/>
                <a:gd name="T3" fmla="*/ 26 h 51"/>
                <a:gd name="T4" fmla="*/ 51 w 51"/>
                <a:gd name="T5" fmla="*/ 0 h 51"/>
                <a:gd name="T6" fmla="*/ 51 w 51"/>
                <a:gd name="T7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1">
                  <a:moveTo>
                    <a:pt x="51" y="51"/>
                  </a:moveTo>
                  <a:lnTo>
                    <a:pt x="0" y="26"/>
                  </a:lnTo>
                  <a:lnTo>
                    <a:pt x="51" y="0"/>
                  </a:lnTo>
                  <a:lnTo>
                    <a:pt x="51" y="51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900E57B2-02C6-AE65-785C-498795C930A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" y="1784"/>
              <a:ext cx="340" cy="302"/>
            </a:xfrm>
            <a:custGeom>
              <a:avLst/>
              <a:gdLst>
                <a:gd name="T0" fmla="*/ 340 w 340"/>
                <a:gd name="T1" fmla="*/ 302 h 302"/>
                <a:gd name="T2" fmla="*/ 0 w 340"/>
                <a:gd name="T3" fmla="*/ 302 h 302"/>
                <a:gd name="T4" fmla="*/ 0 w 340"/>
                <a:gd name="T5" fmla="*/ 0 h 3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0" h="302">
                  <a:moveTo>
                    <a:pt x="340" y="302"/>
                  </a:moveTo>
                  <a:lnTo>
                    <a:pt x="0" y="302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CD0D5B05-22D3-146F-CE02-2BD3D0784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" y="1738"/>
              <a:ext cx="53" cy="53"/>
            </a:xfrm>
            <a:custGeom>
              <a:avLst/>
              <a:gdLst>
                <a:gd name="T0" fmla="*/ 0 w 53"/>
                <a:gd name="T1" fmla="*/ 53 h 53"/>
                <a:gd name="T2" fmla="*/ 28 w 53"/>
                <a:gd name="T3" fmla="*/ 0 h 53"/>
                <a:gd name="T4" fmla="*/ 53 w 53"/>
                <a:gd name="T5" fmla="*/ 53 h 53"/>
                <a:gd name="T6" fmla="*/ 0 w 53"/>
                <a:gd name="T7" fmla="*/ 53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" h="53">
                  <a:moveTo>
                    <a:pt x="0" y="53"/>
                  </a:moveTo>
                  <a:lnTo>
                    <a:pt x="28" y="0"/>
                  </a:lnTo>
                  <a:lnTo>
                    <a:pt x="53" y="53"/>
                  </a:lnTo>
                  <a:lnTo>
                    <a:pt x="0" y="5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7B94EA19-ACD3-0844-8E5A-3564DEFAD21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3" y="1084"/>
              <a:ext cx="339" cy="361"/>
            </a:xfrm>
            <a:custGeom>
              <a:avLst/>
              <a:gdLst>
                <a:gd name="T0" fmla="*/ 339 w 339"/>
                <a:gd name="T1" fmla="*/ 361 h 361"/>
                <a:gd name="T2" fmla="*/ 339 w 339"/>
                <a:gd name="T3" fmla="*/ 0 h 361"/>
                <a:gd name="T4" fmla="*/ 0 w 339"/>
                <a:gd name="T5" fmla="*/ 0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9" h="361">
                  <a:moveTo>
                    <a:pt x="339" y="361"/>
                  </a:moveTo>
                  <a:lnTo>
                    <a:pt x="339" y="0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3847DA13-420F-ABC0-674B-E315FC8DC4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" y="1084"/>
              <a:ext cx="293" cy="361"/>
            </a:xfrm>
            <a:custGeom>
              <a:avLst/>
              <a:gdLst>
                <a:gd name="T0" fmla="*/ 0 w 293"/>
                <a:gd name="T1" fmla="*/ 361 h 361"/>
                <a:gd name="T2" fmla="*/ 0 w 293"/>
                <a:gd name="T3" fmla="*/ 0 h 361"/>
                <a:gd name="T4" fmla="*/ 293 w 293"/>
                <a:gd name="T5" fmla="*/ 0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3" h="361">
                  <a:moveTo>
                    <a:pt x="0" y="361"/>
                  </a:moveTo>
                  <a:lnTo>
                    <a:pt x="0" y="0"/>
                  </a:lnTo>
                  <a:lnTo>
                    <a:pt x="29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2" name="Freeform 41">
              <a:extLst>
                <a:ext uri="{FF2B5EF4-FFF2-40B4-BE49-F238E27FC236}">
                  <a16:creationId xmlns:a16="http://schemas.microsoft.com/office/drawing/2014/main" id="{C47AD8FE-C155-CA57-4A53-D5CA5452E961}"/>
                </a:ext>
              </a:extLst>
            </p:cNvPr>
            <p:cNvSpPr>
              <a:spLocks/>
            </p:cNvSpPr>
            <p:nvPr/>
          </p:nvSpPr>
          <p:spPr bwMode="auto">
            <a:xfrm>
              <a:off x="656" y="1058"/>
              <a:ext cx="53" cy="53"/>
            </a:xfrm>
            <a:custGeom>
              <a:avLst/>
              <a:gdLst>
                <a:gd name="T0" fmla="*/ 0 w 53"/>
                <a:gd name="T1" fmla="*/ 0 h 53"/>
                <a:gd name="T2" fmla="*/ 53 w 53"/>
                <a:gd name="T3" fmla="*/ 26 h 53"/>
                <a:gd name="T4" fmla="*/ 0 w 53"/>
                <a:gd name="T5" fmla="*/ 53 h 53"/>
                <a:gd name="T6" fmla="*/ 0 w 53"/>
                <a:gd name="T7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" h="53">
                  <a:moveTo>
                    <a:pt x="0" y="0"/>
                  </a:moveTo>
                  <a:lnTo>
                    <a:pt x="53" y="26"/>
                  </a:lnTo>
                  <a:lnTo>
                    <a:pt x="0" y="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09D342BB-4335-EBC4-DE18-3852AC05C90A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" y="768"/>
              <a:ext cx="340" cy="316"/>
            </a:xfrm>
            <a:custGeom>
              <a:avLst/>
              <a:gdLst>
                <a:gd name="T0" fmla="*/ 340 w 340"/>
                <a:gd name="T1" fmla="*/ 316 h 316"/>
                <a:gd name="T2" fmla="*/ 0 w 340"/>
                <a:gd name="T3" fmla="*/ 316 h 316"/>
                <a:gd name="T4" fmla="*/ 0 w 340"/>
                <a:gd name="T5" fmla="*/ 0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0" h="316">
                  <a:moveTo>
                    <a:pt x="340" y="316"/>
                  </a:moveTo>
                  <a:lnTo>
                    <a:pt x="0" y="316"/>
                  </a:lnTo>
                  <a:lnTo>
                    <a:pt x="0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AEB76DF5-E528-FB2C-7BB4-85B2200312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1" y="723"/>
              <a:ext cx="53" cy="52"/>
            </a:xfrm>
            <a:custGeom>
              <a:avLst/>
              <a:gdLst>
                <a:gd name="T0" fmla="*/ 0 w 53"/>
                <a:gd name="T1" fmla="*/ 52 h 52"/>
                <a:gd name="T2" fmla="*/ 28 w 53"/>
                <a:gd name="T3" fmla="*/ 0 h 52"/>
                <a:gd name="T4" fmla="*/ 53 w 53"/>
                <a:gd name="T5" fmla="*/ 52 h 52"/>
                <a:gd name="T6" fmla="*/ 0 w 53"/>
                <a:gd name="T7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3" h="52">
                  <a:moveTo>
                    <a:pt x="0" y="52"/>
                  </a:moveTo>
                  <a:lnTo>
                    <a:pt x="28" y="0"/>
                  </a:lnTo>
                  <a:lnTo>
                    <a:pt x="53" y="52"/>
                  </a:lnTo>
                  <a:lnTo>
                    <a:pt x="0" y="52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61BF40B7-78CF-47F8-5E4E-6E805D622D1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9" y="723"/>
              <a:ext cx="293" cy="361"/>
            </a:xfrm>
            <a:custGeom>
              <a:avLst/>
              <a:gdLst>
                <a:gd name="T0" fmla="*/ 0 w 293"/>
                <a:gd name="T1" fmla="*/ 361 h 361"/>
                <a:gd name="T2" fmla="*/ 293 w 293"/>
                <a:gd name="T3" fmla="*/ 361 h 361"/>
                <a:gd name="T4" fmla="*/ 293 w 293"/>
                <a:gd name="T5" fmla="*/ 0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3" h="361">
                  <a:moveTo>
                    <a:pt x="0" y="361"/>
                  </a:moveTo>
                  <a:lnTo>
                    <a:pt x="293" y="361"/>
                  </a:lnTo>
                  <a:lnTo>
                    <a:pt x="293" y="0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133AEAE0-1C0E-EA1E-AA86-EEABD8DEEF7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3" y="1058"/>
              <a:ext cx="51" cy="53"/>
            </a:xfrm>
            <a:custGeom>
              <a:avLst/>
              <a:gdLst>
                <a:gd name="T0" fmla="*/ 51 w 51"/>
                <a:gd name="T1" fmla="*/ 53 h 53"/>
                <a:gd name="T2" fmla="*/ 0 w 51"/>
                <a:gd name="T3" fmla="*/ 26 h 53"/>
                <a:gd name="T4" fmla="*/ 51 w 51"/>
                <a:gd name="T5" fmla="*/ 0 h 53"/>
                <a:gd name="T6" fmla="*/ 51 w 51"/>
                <a:gd name="T7" fmla="*/ 53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1" h="53">
                  <a:moveTo>
                    <a:pt x="51" y="53"/>
                  </a:moveTo>
                  <a:lnTo>
                    <a:pt x="0" y="26"/>
                  </a:lnTo>
                  <a:lnTo>
                    <a:pt x="51" y="0"/>
                  </a:lnTo>
                  <a:lnTo>
                    <a:pt x="51" y="53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164611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宽屏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</cp:revision>
  <dcterms:created xsi:type="dcterms:W3CDTF">2022-12-02T05:30:11Z</dcterms:created>
  <dcterms:modified xsi:type="dcterms:W3CDTF">2022-12-02T05:30:18Z</dcterms:modified>
</cp:coreProperties>
</file>